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8" autoAdjust="0"/>
    <p:restoredTop sz="94660"/>
  </p:normalViewPr>
  <p:slideViewPr>
    <p:cSldViewPr snapToGrid="0">
      <p:cViewPr varScale="1">
        <p:scale>
          <a:sx n="62" d="100"/>
          <a:sy n="62" d="100"/>
        </p:scale>
        <p:origin x="32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FF6647-AD20-1E35-7F7C-F33AED9BEF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1764CB1-5D9E-965E-CF4F-8ED6627A6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9B6773-D662-5D4D-B200-2236A1229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680814-D8B5-2B0A-C62B-E392CF937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5C8835-D6E3-EDAB-D52A-84D7169C9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3647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B5B028-BA0A-438F-351D-EC61DF851C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73CEF71-9AFB-96F9-1DBB-94DBEC618B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3BDA7F-108F-EB76-7D11-0E66767FC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11248F-9E76-1825-A016-8671120DF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F6E0D6-048D-7FDC-7133-06C396F1F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3420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0D374D1-096B-89ED-7E57-C673876925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CEDD4F2-67D2-12E2-3E31-8424451C8A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08AF36-7B03-A968-D730-F66CD1AE1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2B9B73-4FE2-39B3-F2B6-C2B231BA6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C667D7-58EF-D49F-93E5-F7E86629C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596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88BC0B-AF7A-DB27-6C0B-92DBA119BE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FE8EC0D-E23E-020A-E494-53C7A80151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BF541B-6C43-5660-D68A-EE97E3A21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8EA91E-31DA-79F1-30BF-0FA4B33CB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883B40-E5FC-1F7C-DCA9-9EA45EB96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1768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5E6603-121E-D62A-7E3B-A7774D4556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5193028-C238-5C96-C33C-69554A9997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38F26B0-0548-8E70-0989-B92651359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479C71-5FB5-79BB-8D05-326AD177E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4093BE-8CE3-0A83-964B-9681E28FD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7582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124533-AF33-8DE8-C3D2-1682D6A64D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E9D63E-4A19-07A8-7E40-1267F1516F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430359E-66F2-0282-C871-020FE0D391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EE6C5DF-3E3F-753A-AB65-45C6383547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D8D76FB-C792-B93E-2A5B-A7B47CBB4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CA8135-9146-FE40-BA06-A2D67C8F9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5292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235AA4-5D72-8308-4114-670FD81651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AFF5102-64CE-FE08-1587-87B512187F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C3D8BF2-47D1-76EF-22CC-AE62C2DA55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73EAD3D-1653-EE27-C857-24DCF97D71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DC9A1F8-8004-2AB2-4AD3-2B7EFBDF58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78290C4-04D9-07B5-3842-4436731DA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881F6E2-05EF-DB7D-13CF-9AB757E0E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E7EE855-77E3-95CD-2A8C-5461F23A9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5463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95456D-49DE-0099-12E5-8E2D41D7F5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BB8C105-9BCE-D7B9-FA9E-8CADD68EB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1CFFF31-C01F-0EAA-3235-5E72C9343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B8E9E4B-314A-1EBA-7499-6DEF4D11A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24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EEB23F1-57FE-4AA2-D214-59F5A9278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C689CC1-224D-EFC0-C1CE-E0183B2DB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53F006C-2D2E-A8A3-DDFD-D8B83C0C2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237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1A27C0-FCC3-7DC0-F058-AF1601EE8D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4E00D13-FE40-1A78-230B-99D57842B4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C2B18D4-E59D-229A-E771-1805068C92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2E3EFF5-A94A-D06E-B033-1379E6889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CDC120D-9EDC-F98A-AB7D-BD994C1C9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0C2AA24-60A3-C534-7F8C-E1BC70AE0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1351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4E8EE9-334A-9DE8-7E62-D565F71DBC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A867ECF-97DA-AA65-155A-6F9E4D72D3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3E22F3A-46A4-D74C-FC2C-AD4D79E06E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2D6F21A-B9CC-1519-5E68-220A138972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C1E7B1F-7073-C7CE-4967-7AD894A9C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95DDC84-AEA9-8979-C1C1-B60B076CF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934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1AD228D-9B9E-057D-5D52-46FF64D60D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26E3FA5-FA2E-0F6C-15D1-2568586AD1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B06ADE-A861-9B4A-5902-2D0BAD7F19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1C291-35B3-40AB-83A0-58299AB8EE24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B3645E-5496-DE6C-5CD4-45DCB35DB0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78FBF7-6B36-8568-BCA5-488E52DBF9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8438F-471E-464D-9E17-B0AAF7DC71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3040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4">
            <a:extLst>
              <a:ext uri="{FF2B5EF4-FFF2-40B4-BE49-F238E27FC236}">
                <a16:creationId xmlns:a16="http://schemas.microsoft.com/office/drawing/2014/main" id="{0D5DAE2B-3C91-0EB0-516E-214F7DE62697}"/>
              </a:ext>
            </a:extLst>
          </p:cNvPr>
          <p:cNvSpPr txBox="1"/>
          <p:nvPr/>
        </p:nvSpPr>
        <p:spPr>
          <a:xfrm flipH="1">
            <a:off x="324103" y="317912"/>
            <a:ext cx="29122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9E97079-E615-FAFF-D0FB-59817173A5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4646" y="1046467"/>
            <a:ext cx="2346960" cy="31623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01A97F8-7C6D-4DB9-4648-876F1E075D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6290" y="1042828"/>
            <a:ext cx="2979420" cy="31623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4A7EFB05-3604-DFBF-FD32-173D04F02B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11880" y="1042828"/>
            <a:ext cx="3032760" cy="31623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B4D10BF-8DD7-F80F-2A8F-DE553709257B}"/>
              </a:ext>
            </a:extLst>
          </p:cNvPr>
          <p:cNvSpPr txBox="1"/>
          <p:nvPr/>
        </p:nvSpPr>
        <p:spPr>
          <a:xfrm>
            <a:off x="750013" y="4428166"/>
            <a:ext cx="10870059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lvl="0" indent="-342900" algn="l">
              <a:buFont typeface="+mj-lt"/>
              <a:buAutoNum type="alphaUcParenBoth"/>
            </a:pP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HEK293T cells were transfected with LV mix together with 0.1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EV1 and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025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EV3 (left) or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1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/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CMVrelA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and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025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S-Mincho"/>
                <a:cs typeface="Arial" panose="020B0604020202020204" pitchFamily="34" charset="0"/>
              </a:rPr>
              <a:t>pcDNA3HA-MAP3K1CD (right).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Luciferase activity was measured and shown as in Figure 1 (A).</a:t>
            </a:r>
            <a:endParaRPr lang="ja-JP" altLang="ja-JP" sz="16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marL="342900" lvl="0" indent="-342900" algn="l">
              <a:buFont typeface="+mj-lt"/>
              <a:buAutoNum type="alphaUcParenBoth"/>
            </a:pP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HEK293T cells were transfected with LV mix together with 0.2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EV1 (left),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1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/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CMVrelA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and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1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EV1 (middle),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1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/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CMVrelA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and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1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/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CMV-IkB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α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S-Mincho"/>
                <a:cs typeface="Arial" panose="020B0604020202020204" pitchFamily="34" charset="0"/>
              </a:rPr>
              <a:t> (right).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Luciferase activity was measured and shown as in Figure 1 (A).</a:t>
            </a:r>
            <a:endParaRPr lang="ja-JP" altLang="ja-JP" sz="16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marL="342900" lvl="0" indent="-342900" algn="l">
              <a:buFont typeface="+mj-lt"/>
              <a:buAutoNum type="alphaUcParenBoth"/>
            </a:pP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HEK293T cells were transfected with LV mix together with 0.05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EV3 and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1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EV1 (left),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05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S-Mincho"/>
                <a:cs typeface="Arial" panose="020B0604020202020204" pitchFamily="34" charset="0"/>
              </a:rPr>
              <a:t>pcDNA3HA-MAP3K1CD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and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1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EV1 (middle),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05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S-Mincho"/>
                <a:cs typeface="Arial" panose="020B0604020202020204" pitchFamily="34" charset="0"/>
              </a:rPr>
              <a:t>pcDNA3HA-MAP3K1CD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and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0.1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STIX"/>
                <a:cs typeface="Arial" panose="020B0604020202020204" pitchFamily="34" charset="0"/>
              </a:rPr>
              <a:t>μ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/</a:t>
            </a:r>
            <a:r>
              <a:rPr lang="en-US" altLang="ja-JP" sz="16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CMV-IkB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α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MS-Mincho"/>
                <a:cs typeface="Arial" panose="020B0604020202020204" pitchFamily="34" charset="0"/>
              </a:rPr>
              <a:t> (right).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Luciferase activity was measured and shown as in Figure 1 (A).</a:t>
            </a:r>
            <a:endParaRPr lang="ja-JP" altLang="ja-JP" sz="16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7596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</Words>
  <Application>Microsoft Office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岡 昇司</dc:creator>
  <cp:lastModifiedBy>山岡 昇司</cp:lastModifiedBy>
  <cp:revision>1</cp:revision>
  <dcterms:created xsi:type="dcterms:W3CDTF">2023-10-12T04:21:15Z</dcterms:created>
  <dcterms:modified xsi:type="dcterms:W3CDTF">2023-10-12T04:22:01Z</dcterms:modified>
</cp:coreProperties>
</file>